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1" r:id="rId2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5B61F6-4EA3-4618-BB26-2AF38672691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4" name="Pladsholder til slide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BE8E17-1F6D-40F2-A04C-1D0EA00EB34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29367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a-DK" dirty="0"/>
              <a:t>Se U-TURN beskrivelse af medicin</a:t>
            </a:r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DBD4031-C5FF-424C-8D12-201FF30B509A}" type="slidenum">
              <a:rPr kumimoji="0" lang="da-DK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da-DK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0042827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27B84F6-C5C1-48E5-BBC5-816553ACE1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08D61DF6-8529-49DF-8EAC-0794A1296C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1E9ADD0A-FDDD-4F1A-ADD5-84F13FFFF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33B15D20-CD73-4F54-9DF5-292813648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E7C95C43-87A7-48BC-8B40-822F1D7C3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01268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AF19D4-BAFE-4A41-BCC5-9449D31507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57C343A4-4E1E-4A8E-81D2-A65036F98C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F4C340DC-9EA9-4EFC-9EB8-1F99E812E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B3F96AA0-E412-400D-B2F0-F84A5D87D5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2954350A-017C-42AD-9A6A-FFF605491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0865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3766754E-34E6-480B-99EE-E0043C706B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7B2CFFE1-BE3A-47D0-8AE5-DC29CAED22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2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1D3907D3-1D2F-4666-ADD4-BF7F9C37D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F35983E7-656D-408A-95AC-2485004AE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EB8C9AD1-5B68-448D-BE9C-0C8727CD2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677650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84C449F-F577-415E-9877-0283D0E55B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FCB648FC-3CEE-4CB0-9478-F7019ABA1E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B1EFDF41-2A6A-4236-BD5E-D46252A25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5879D40C-861D-4F79-ADA0-F18FB9A81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82806B96-0A50-485B-B8A5-7B3CBBC5A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14376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DCE46E-250F-4AFF-AD40-4427AE89C5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42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E3629A44-C6A5-4182-B5E8-13BD69C4AF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67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AB2C32B9-1BCD-48BE-9571-3FE0EB96D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4D01304F-3104-4726-84E5-446E1C19F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A7B8FBF1-C98A-4497-9FF6-AE4FDA51B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72711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F5A58E2-281F-4038-923E-553E479EA6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3B87FAEC-C585-4033-B5F2-93BDB9EEA4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4114BEB2-4529-4830-A7C9-03F1D518C8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C8F6ACC7-A23D-4156-B0F8-4E5120C61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A67D9D28-452B-4F88-B16F-3EE67201B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C7D6C72D-8313-4C06-85B7-2269C0D76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29156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642505F-DF35-4A56-82E2-B715AAEEB7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9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5C4DF33F-145D-46FD-8C91-DCCAD6CA25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B29EEBD8-8512-45FB-B3AE-1B7C09EFD4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A0161E56-B1F6-4376-B641-E49FD64FD9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5F5A0EB2-9839-477B-8A6A-1DE30217AA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3DBC4AEB-BEB8-463F-98B4-34E6D1BF0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057A37A3-B65E-4BE6-BA12-A5AF07248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989919D4-6C61-4F1B-A51B-E2FA3B31D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66142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E7EE953-F257-4E7C-9BEB-355A0D972D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0A3B41BB-B439-4A15-975C-7DD846955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EBED6354-6866-4FDA-87BB-A3BAA28CC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E12C3543-4C75-4CEA-A267-C05E69F12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451385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3FC2E26D-27B9-4677-8DD2-BB67E99EC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240B5AEE-BFD0-4D81-9991-947C28BDC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9A52F5A6-BB36-4B61-BB94-534294970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33454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B1714A6-BEEA-40E8-B2B1-A03329DF94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834BE7A6-554A-43BB-A8AD-778E8EEE7C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87C3A7F0-CD0F-4854-B90D-5600529DE1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D4C35AC9-1AA3-42F5-8D4E-6DBBB3C0E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B3ABC9BD-D4C2-4660-A6EB-DB82C1C99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ADA2A3B8-60F6-40C3-84F1-FF4200034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42514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1614D81-4615-4F62-B5A6-92D017AED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C75CB739-F400-4E16-8698-5B14791885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da-DK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63881E13-B3E1-476C-AF04-2B918A5FFA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C2EC1F53-CE3B-472E-844F-164A3402D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A9548CD9-0BEF-4360-942B-1929D3502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4D9FEAB6-1B5C-468D-B537-25D0963404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979213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303F650D-A02C-4ED2-995E-331C7B1D2F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9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C7C48C35-0B92-4FBD-83BE-7D97DD09CA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FF8E0098-1B49-4FDC-9731-74D65D0D5D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C1D1A-8584-4828-B3AF-B4638A3AA804}" type="datetimeFigureOut">
              <a:rPr lang="da-DK" smtClean="0"/>
              <a:t>16-09-2020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30DA9E09-6799-41BF-AEE0-50BC9BAA23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4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E11E64B1-7521-4018-80EF-311BAC1D20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DB771-5250-482A-980F-4499830E1ED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6327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kstfelt 74">
            <a:extLst>
              <a:ext uri="{FF2B5EF4-FFF2-40B4-BE49-F238E27FC236}">
                <a16:creationId xmlns:a16="http://schemas.microsoft.com/office/drawing/2014/main" id="{F9F0E96A-BE95-48AE-85D8-E6BC6C1EFB36}"/>
              </a:ext>
            </a:extLst>
          </p:cNvPr>
          <p:cNvSpPr txBox="1"/>
          <p:nvPr/>
        </p:nvSpPr>
        <p:spPr>
          <a:xfrm>
            <a:off x="1434680" y="5537849"/>
            <a:ext cx="1459890" cy="21358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 defTabSz="457200"/>
            <a:r>
              <a:rPr lang="da-DK" sz="788" b="1" dirty="0" err="1">
                <a:solidFill>
                  <a:prstClr val="black"/>
                </a:solidFill>
                <a:latin typeface="Calibri" panose="020F0502020204030204"/>
              </a:rPr>
              <a:t>Atorvastatin</a:t>
            </a:r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 10 mg x 1</a:t>
            </a:r>
          </a:p>
        </p:txBody>
      </p:sp>
      <p:sp>
        <p:nvSpPr>
          <p:cNvPr id="19" name="Rektangel 18">
            <a:extLst>
              <a:ext uri="{FF2B5EF4-FFF2-40B4-BE49-F238E27FC236}">
                <a16:creationId xmlns:a16="http://schemas.microsoft.com/office/drawing/2014/main" id="{2304861A-4E43-48EB-B7BD-7087B67D6C7D}"/>
              </a:ext>
            </a:extLst>
          </p:cNvPr>
          <p:cNvSpPr/>
          <p:nvPr/>
        </p:nvSpPr>
        <p:spPr>
          <a:xfrm>
            <a:off x="357155" y="105030"/>
            <a:ext cx="305885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685800"/>
            <a:r>
              <a:rPr lang="en-US" sz="1200" dirty="0">
                <a:solidFill>
                  <a:prstClr val="black"/>
                </a:solidFill>
                <a:latin typeface="Times" panose="02020603050405020304" pitchFamily="18" charset="0"/>
                <a:ea typeface="Calibri" panose="020F0502020204030204" pitchFamily="34" charset="0"/>
              </a:rPr>
              <a:t>Appendix 6</a:t>
            </a:r>
          </a:p>
          <a:p>
            <a:pPr defTabSz="685800"/>
            <a:r>
              <a:rPr lang="en-US" sz="1200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Algorithm for pharmacological management </a:t>
            </a:r>
            <a:endParaRPr lang="da-DK" sz="1200" dirty="0">
              <a:solidFill>
                <a:prstClr val="black"/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graphicFrame>
        <p:nvGraphicFramePr>
          <p:cNvPr id="20" name="Tabel 5">
            <a:extLst>
              <a:ext uri="{FF2B5EF4-FFF2-40B4-BE49-F238E27FC236}">
                <a16:creationId xmlns:a16="http://schemas.microsoft.com/office/drawing/2014/main" id="{2FD4F380-DF14-41EB-8448-46607B8451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5784932"/>
              </p:ext>
            </p:extLst>
          </p:nvPr>
        </p:nvGraphicFramePr>
        <p:xfrm>
          <a:off x="357155" y="965886"/>
          <a:ext cx="4834099" cy="146643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74069">
                  <a:extLst>
                    <a:ext uri="{9D8B030D-6E8A-4147-A177-3AD203B41FA5}">
                      <a16:colId xmlns:a16="http://schemas.microsoft.com/office/drawing/2014/main" val="1558821364"/>
                    </a:ext>
                  </a:extLst>
                </a:gridCol>
                <a:gridCol w="1388020">
                  <a:extLst>
                    <a:ext uri="{9D8B030D-6E8A-4147-A177-3AD203B41FA5}">
                      <a16:colId xmlns:a16="http://schemas.microsoft.com/office/drawing/2014/main" val="3847488307"/>
                    </a:ext>
                  </a:extLst>
                </a:gridCol>
                <a:gridCol w="1363838">
                  <a:extLst>
                    <a:ext uri="{9D8B030D-6E8A-4147-A177-3AD203B41FA5}">
                      <a16:colId xmlns:a16="http://schemas.microsoft.com/office/drawing/2014/main" val="847469666"/>
                    </a:ext>
                  </a:extLst>
                </a:gridCol>
                <a:gridCol w="1308172">
                  <a:extLst>
                    <a:ext uri="{9D8B030D-6E8A-4147-A177-3AD203B41FA5}">
                      <a16:colId xmlns:a16="http://schemas.microsoft.com/office/drawing/2014/main" val="4124141257"/>
                    </a:ext>
                  </a:extLst>
                </a:gridCol>
              </a:tblGrid>
              <a:tr h="340952">
                <a:tc>
                  <a:txBody>
                    <a:bodyPr/>
                    <a:lstStyle/>
                    <a:p>
                      <a:endParaRPr lang="da-DK" sz="800" b="1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herapeutic target</a:t>
                      </a:r>
                      <a:endParaRPr lang="da-DK" sz="1000" b="1" i="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ensification of treatment</a:t>
                      </a:r>
                      <a:endParaRPr kumimoji="0" lang="da-DK" sz="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duction in treatment</a:t>
                      </a:r>
                      <a:endParaRPr lang="da-DK" sz="1000" b="1" i="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620649282"/>
                  </a:ext>
                </a:extLst>
              </a:tr>
              <a:tr h="652629">
                <a:tc>
                  <a:txBody>
                    <a:bodyPr/>
                    <a:lstStyle/>
                    <a:p>
                      <a:r>
                        <a:rPr lang="da-DK" sz="800" b="1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 </a:t>
                      </a:r>
                      <a:r>
                        <a:rPr lang="da-DK" sz="800" b="1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se</a:t>
                      </a:r>
                      <a:endParaRPr lang="da-DK" sz="800" b="1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bA1c = 48</a:t>
                      </a:r>
                      <a:r>
                        <a:rPr kumimoji="0" lang="en-GB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mmol/mol</a:t>
                      </a: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kumimoji="0" lang="da-DK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just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asting glucose &lt; 7</a:t>
                      </a:r>
                      <a:r>
                        <a:rPr kumimoji="0" lang="en-GB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mmol/l</a:t>
                      </a:r>
                      <a:endParaRPr kumimoji="0" lang="da-DK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just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stprandial BG &lt; 7,8 </a:t>
                      </a:r>
                      <a:r>
                        <a:rPr kumimoji="0" lang="en-GB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ol/l</a:t>
                      </a:r>
                      <a:endParaRPr kumimoji="0" lang="da-DK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bA1c ≥ 53 </a:t>
                      </a:r>
                      <a:r>
                        <a:rPr kumimoji="0" lang="en-GB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ol/mol</a:t>
                      </a:r>
                    </a:p>
                    <a:p>
                      <a:pPr marL="0" marR="0" lvl="0" indent="0" algn="just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asting BG &gt; 7,0</a:t>
                      </a:r>
                      <a:r>
                        <a:rPr kumimoji="0" lang="en-GB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mmol/l</a:t>
                      </a:r>
                      <a:endParaRPr kumimoji="0" lang="da-DK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just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stprandial PG &gt; 11</a:t>
                      </a:r>
                      <a:r>
                        <a:rPr kumimoji="0" lang="en-GB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mmol/l</a:t>
                      </a:r>
                      <a:endParaRPr lang="da-DK" sz="1000" i="0" dirty="0"/>
                    </a:p>
                  </a:txBody>
                  <a:tcPr marL="68580" marR="68580" marT="34290" marB="34290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bA1c &lt; </a:t>
                      </a:r>
                      <a:r>
                        <a:rPr kumimoji="0" lang="en-GB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8 mmol/mol</a:t>
                      </a:r>
                    </a:p>
                    <a:p>
                      <a:pPr marL="0" marR="0" lvl="0" indent="0" algn="just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asting BG &lt; 7 </a:t>
                      </a:r>
                      <a:r>
                        <a:rPr kumimoji="0" lang="en-GB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ol/l </a:t>
                      </a: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d</a:t>
                      </a:r>
                      <a:endParaRPr kumimoji="0" lang="da-DK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just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stprandial BG&lt; 7,8</a:t>
                      </a:r>
                      <a:r>
                        <a:rPr kumimoji="0" lang="en-GB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mmol/l</a:t>
                      </a:r>
                      <a:endParaRPr kumimoji="0" lang="da-DK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4192513"/>
                  </a:ext>
                </a:extLst>
              </a:tr>
              <a:tr h="256432">
                <a:tc>
                  <a:txBody>
                    <a:bodyPr/>
                    <a:lstStyle/>
                    <a:p>
                      <a:pPr algn="l"/>
                      <a:r>
                        <a:rPr lang="da-DK" sz="800" b="1" i="0" dirty="0"/>
                        <a:t>Blood </a:t>
                      </a:r>
                      <a:r>
                        <a:rPr lang="da-DK" sz="800" b="1" i="0" dirty="0" err="1"/>
                        <a:t>pressure</a:t>
                      </a:r>
                      <a:endParaRPr lang="da-DK" sz="800" b="1" i="0" dirty="0"/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P ≤ 130/80 mmHg</a:t>
                      </a:r>
                      <a:endParaRPr kumimoji="0" lang="da-DK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P &gt; 140/85 mm</a:t>
                      </a: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g</a:t>
                      </a:r>
                      <a:endParaRPr kumimoji="0" lang="da-DK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P &lt; 125 / 75</a:t>
                      </a:r>
                      <a:r>
                        <a:rPr kumimoji="0" lang="en-GB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mmHg</a:t>
                      </a:r>
                      <a:endParaRPr kumimoji="0" lang="da-DK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4062957"/>
                  </a:ext>
                </a:extLst>
              </a:tr>
              <a:tr h="21641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ipids</a:t>
                      </a: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0" lang="da-DK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DLcholesterol</a:t>
                      </a:r>
                      <a:r>
                        <a:rPr kumimoji="0" lang="da-DK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= </a:t>
                      </a:r>
                      <a:r>
                        <a:rPr lang="da-DK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5mmol/l</a:t>
                      </a:r>
                    </a:p>
                  </a:txBody>
                  <a:tcPr marL="68580" marR="68580" marT="34290" marB="34290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0" lang="da-DK" sz="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DLcholesterol</a:t>
                      </a:r>
                      <a:r>
                        <a:rPr kumimoji="0" lang="da-DK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0" lang="en-GB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gt;</a:t>
                      </a:r>
                      <a:r>
                        <a:rPr kumimoji="0" lang="da-DK" sz="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2,5mmol/l</a:t>
                      </a:r>
                      <a:endParaRPr lang="da-DK" sz="1000" i="0" dirty="0"/>
                    </a:p>
                  </a:txBody>
                  <a:tcPr marL="68580" marR="68580" marT="34290" marB="34290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a-DK" sz="800" i="0" dirty="0"/>
                        <a:t>Non</a:t>
                      </a:r>
                    </a:p>
                  </a:txBody>
                  <a:tcPr marL="68580" marR="68580" marT="34290" marB="34290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5325322"/>
                  </a:ext>
                </a:extLst>
              </a:tr>
            </a:tbl>
          </a:graphicData>
        </a:graphic>
      </p:graphicFrame>
      <p:cxnSp>
        <p:nvCxnSpPr>
          <p:cNvPr id="23" name="Lige pilforbindelse 22">
            <a:extLst>
              <a:ext uri="{FF2B5EF4-FFF2-40B4-BE49-F238E27FC236}">
                <a16:creationId xmlns:a16="http://schemas.microsoft.com/office/drawing/2014/main" id="{4CF17D7A-26F9-4308-94C9-7E927B652319}"/>
              </a:ext>
            </a:extLst>
          </p:cNvPr>
          <p:cNvCxnSpPr>
            <a:cxnSpLocks/>
          </p:cNvCxnSpPr>
          <p:nvPr/>
        </p:nvCxnSpPr>
        <p:spPr>
          <a:xfrm flipV="1">
            <a:off x="2890691" y="4066849"/>
            <a:ext cx="4124131" cy="196176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kstfelt 23">
            <a:extLst>
              <a:ext uri="{FF2B5EF4-FFF2-40B4-BE49-F238E27FC236}">
                <a16:creationId xmlns:a16="http://schemas.microsoft.com/office/drawing/2014/main" id="{7174BDE4-ACED-4553-B850-00F5147CFFA6}"/>
              </a:ext>
            </a:extLst>
          </p:cNvPr>
          <p:cNvSpPr txBox="1"/>
          <p:nvPr/>
        </p:nvSpPr>
        <p:spPr>
          <a:xfrm>
            <a:off x="2908403" y="4437852"/>
            <a:ext cx="1348934" cy="334835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AT-2 antagonists 100 mg/</a:t>
            </a:r>
          </a:p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ACE inhibitor 20 mg</a:t>
            </a:r>
          </a:p>
        </p:txBody>
      </p:sp>
      <p:sp>
        <p:nvSpPr>
          <p:cNvPr id="25" name="Tekstfelt 24">
            <a:extLst>
              <a:ext uri="{FF2B5EF4-FFF2-40B4-BE49-F238E27FC236}">
                <a16:creationId xmlns:a16="http://schemas.microsoft.com/office/drawing/2014/main" id="{922E1037-DCCA-4062-ACAD-43E1BFCC5FB0}"/>
              </a:ext>
            </a:extLst>
          </p:cNvPr>
          <p:cNvSpPr txBox="1"/>
          <p:nvPr/>
        </p:nvSpPr>
        <p:spPr>
          <a:xfrm>
            <a:off x="4283252" y="3279394"/>
            <a:ext cx="1744121" cy="716294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AT-2 antagonists 100 mg/</a:t>
            </a:r>
          </a:p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ACE inhibitor 20 mg</a:t>
            </a:r>
          </a:p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+</a:t>
            </a:r>
            <a:endParaRPr lang="da-DK" sz="1350" dirty="0">
              <a:solidFill>
                <a:prstClr val="black"/>
              </a:solidFill>
              <a:latin typeface="Calibri" panose="020F0502020204030204"/>
            </a:endParaRPr>
          </a:p>
          <a:p>
            <a:pPr algn="ctr" defTabSz="685800"/>
            <a:r>
              <a:rPr lang="en-US" sz="788" b="1" dirty="0">
                <a:solidFill>
                  <a:prstClr val="black"/>
                </a:solidFill>
                <a:latin typeface="Calibri" panose="020F0502020204030204"/>
              </a:rPr>
              <a:t>Calcium channel antagonist 5-10 mg/  </a:t>
            </a:r>
          </a:p>
          <a:p>
            <a:pPr algn="ctr" defTabSz="685800"/>
            <a:r>
              <a:rPr lang="en-US" sz="788" b="1" dirty="0">
                <a:solidFill>
                  <a:prstClr val="black"/>
                </a:solidFill>
                <a:latin typeface="Calibri" panose="020F0502020204030204"/>
              </a:rPr>
              <a:t>Thiazide diuretic 1,25-2,5 mg </a:t>
            </a:r>
            <a:endParaRPr lang="da-DK" sz="788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6" name="Tekstfelt 25">
            <a:extLst>
              <a:ext uri="{FF2B5EF4-FFF2-40B4-BE49-F238E27FC236}">
                <a16:creationId xmlns:a16="http://schemas.microsoft.com/office/drawing/2014/main" id="{8DCF8CCD-2068-4044-9A5A-93EEBF1D53FF}"/>
              </a:ext>
            </a:extLst>
          </p:cNvPr>
          <p:cNvSpPr txBox="1"/>
          <p:nvPr/>
        </p:nvSpPr>
        <p:spPr>
          <a:xfrm>
            <a:off x="6030866" y="2487133"/>
            <a:ext cx="2164961" cy="698589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AT-2 antagonists 100 mg/ACE inhibitor 20 mg</a:t>
            </a:r>
          </a:p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+</a:t>
            </a:r>
            <a:endParaRPr lang="da-DK" sz="1350" dirty="0">
              <a:solidFill>
                <a:prstClr val="black"/>
              </a:solidFill>
              <a:latin typeface="Calibri" panose="020F0502020204030204"/>
            </a:endParaRPr>
          </a:p>
          <a:p>
            <a:pPr algn="ctr" defTabSz="685800"/>
            <a:r>
              <a:rPr lang="en-US" sz="788" b="1" dirty="0">
                <a:solidFill>
                  <a:prstClr val="black"/>
                </a:solidFill>
                <a:latin typeface="Calibri" panose="020F0502020204030204"/>
              </a:rPr>
              <a:t>Calcium channel antagonist 5-10 mg</a:t>
            </a:r>
          </a:p>
          <a:p>
            <a:pPr algn="ctr" defTabSz="685800"/>
            <a:r>
              <a:rPr lang="en-US" sz="788" b="1" dirty="0">
                <a:solidFill>
                  <a:prstClr val="black"/>
                </a:solidFill>
                <a:latin typeface="Calibri" panose="020F0502020204030204"/>
              </a:rPr>
              <a:t>+ </a:t>
            </a:r>
          </a:p>
          <a:p>
            <a:pPr algn="ctr" defTabSz="685800"/>
            <a:r>
              <a:rPr lang="en-US" sz="788" b="1" dirty="0">
                <a:solidFill>
                  <a:prstClr val="black"/>
                </a:solidFill>
                <a:latin typeface="Calibri" panose="020F0502020204030204"/>
              </a:rPr>
              <a:t>Thiazide diuretic 1,25-2,5 mg </a:t>
            </a:r>
            <a:endParaRPr lang="da-DK" sz="788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8" name="Tekstfelt 27">
            <a:extLst>
              <a:ext uri="{FF2B5EF4-FFF2-40B4-BE49-F238E27FC236}">
                <a16:creationId xmlns:a16="http://schemas.microsoft.com/office/drawing/2014/main" id="{3DB06B14-CD0F-44BE-AD02-2CEBCEF2FED7}"/>
              </a:ext>
            </a:extLst>
          </p:cNvPr>
          <p:cNvSpPr txBox="1"/>
          <p:nvPr/>
        </p:nvSpPr>
        <p:spPr>
          <a:xfrm>
            <a:off x="2530340" y="5895448"/>
            <a:ext cx="24412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/>
            <a:r>
              <a:rPr lang="da-DK" sz="1350" dirty="0">
                <a:solidFill>
                  <a:prstClr val="black"/>
                </a:solidFill>
                <a:latin typeface="Calibri" panose="020F0502020204030204"/>
              </a:rPr>
              <a:t>-</a:t>
            </a:r>
          </a:p>
        </p:txBody>
      </p:sp>
      <p:sp>
        <p:nvSpPr>
          <p:cNvPr id="29" name="Tekstfelt 28">
            <a:extLst>
              <a:ext uri="{FF2B5EF4-FFF2-40B4-BE49-F238E27FC236}">
                <a16:creationId xmlns:a16="http://schemas.microsoft.com/office/drawing/2014/main" id="{84264C2A-5E84-4867-A8C8-9A602C8469F8}"/>
              </a:ext>
            </a:extLst>
          </p:cNvPr>
          <p:cNvSpPr txBox="1"/>
          <p:nvPr/>
        </p:nvSpPr>
        <p:spPr>
          <a:xfrm>
            <a:off x="7082874" y="3830278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da-DK" sz="1350" dirty="0">
                <a:solidFill>
                  <a:prstClr val="black"/>
                </a:solidFill>
                <a:latin typeface="Calibri" panose="020F0502020204030204"/>
              </a:rPr>
              <a:t>+</a:t>
            </a:r>
          </a:p>
        </p:txBody>
      </p:sp>
      <p:cxnSp>
        <p:nvCxnSpPr>
          <p:cNvPr id="32" name="Lige forbindelse 31">
            <a:extLst>
              <a:ext uri="{FF2B5EF4-FFF2-40B4-BE49-F238E27FC236}">
                <a16:creationId xmlns:a16="http://schemas.microsoft.com/office/drawing/2014/main" id="{C21534DD-C6A2-4CE9-83C8-90BD37425D77}"/>
              </a:ext>
            </a:extLst>
          </p:cNvPr>
          <p:cNvCxnSpPr>
            <a:cxnSpLocks/>
          </p:cNvCxnSpPr>
          <p:nvPr/>
        </p:nvCxnSpPr>
        <p:spPr>
          <a:xfrm flipV="1">
            <a:off x="1446435" y="5760770"/>
            <a:ext cx="0" cy="35228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Lige forbindelse 33">
            <a:extLst>
              <a:ext uri="{FF2B5EF4-FFF2-40B4-BE49-F238E27FC236}">
                <a16:creationId xmlns:a16="http://schemas.microsoft.com/office/drawing/2014/main" id="{A188E156-62C2-4729-AADB-C14A3D2992FE}"/>
              </a:ext>
            </a:extLst>
          </p:cNvPr>
          <p:cNvCxnSpPr>
            <a:cxnSpLocks/>
          </p:cNvCxnSpPr>
          <p:nvPr/>
        </p:nvCxnSpPr>
        <p:spPr>
          <a:xfrm flipH="1">
            <a:off x="1444138" y="5778220"/>
            <a:ext cx="143602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Lige forbindelse 42">
            <a:extLst>
              <a:ext uri="{FF2B5EF4-FFF2-40B4-BE49-F238E27FC236}">
                <a16:creationId xmlns:a16="http://schemas.microsoft.com/office/drawing/2014/main" id="{B4B5247B-D0BA-4779-990A-5C5EE46DEED1}"/>
              </a:ext>
            </a:extLst>
          </p:cNvPr>
          <p:cNvCxnSpPr>
            <a:cxnSpLocks/>
          </p:cNvCxnSpPr>
          <p:nvPr/>
        </p:nvCxnSpPr>
        <p:spPr>
          <a:xfrm flipV="1">
            <a:off x="4281494" y="4219955"/>
            <a:ext cx="0" cy="78701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Lige forbindelse 44">
            <a:extLst>
              <a:ext uri="{FF2B5EF4-FFF2-40B4-BE49-F238E27FC236}">
                <a16:creationId xmlns:a16="http://schemas.microsoft.com/office/drawing/2014/main" id="{9B982F46-E4E0-4009-BEF9-DF6117376217}"/>
              </a:ext>
            </a:extLst>
          </p:cNvPr>
          <p:cNvCxnSpPr>
            <a:cxnSpLocks/>
          </p:cNvCxnSpPr>
          <p:nvPr/>
        </p:nvCxnSpPr>
        <p:spPr>
          <a:xfrm flipH="1">
            <a:off x="2895237" y="5006974"/>
            <a:ext cx="14040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Lige forbindelse 45">
            <a:extLst>
              <a:ext uri="{FF2B5EF4-FFF2-40B4-BE49-F238E27FC236}">
                <a16:creationId xmlns:a16="http://schemas.microsoft.com/office/drawing/2014/main" id="{87C11FBE-93AD-4BE0-A829-E9BF0CEE89E3}"/>
              </a:ext>
            </a:extLst>
          </p:cNvPr>
          <p:cNvCxnSpPr>
            <a:cxnSpLocks/>
          </p:cNvCxnSpPr>
          <p:nvPr/>
        </p:nvCxnSpPr>
        <p:spPr>
          <a:xfrm flipH="1">
            <a:off x="4260857" y="4231192"/>
            <a:ext cx="17608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Lige forbindelse 46">
            <a:extLst>
              <a:ext uri="{FF2B5EF4-FFF2-40B4-BE49-F238E27FC236}">
                <a16:creationId xmlns:a16="http://schemas.microsoft.com/office/drawing/2014/main" id="{E87D207E-A441-4A48-A03F-E5621DF4B72B}"/>
              </a:ext>
            </a:extLst>
          </p:cNvPr>
          <p:cNvCxnSpPr>
            <a:cxnSpLocks/>
          </p:cNvCxnSpPr>
          <p:nvPr/>
        </p:nvCxnSpPr>
        <p:spPr>
          <a:xfrm flipH="1">
            <a:off x="6021295" y="3421220"/>
            <a:ext cx="21768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Lige forbindelse 34">
            <a:extLst>
              <a:ext uri="{FF2B5EF4-FFF2-40B4-BE49-F238E27FC236}">
                <a16:creationId xmlns:a16="http://schemas.microsoft.com/office/drawing/2014/main" id="{DCD46AB5-7C16-48C7-B7E3-28F3FB90A96B}"/>
              </a:ext>
            </a:extLst>
          </p:cNvPr>
          <p:cNvCxnSpPr>
            <a:cxnSpLocks/>
          </p:cNvCxnSpPr>
          <p:nvPr/>
        </p:nvCxnSpPr>
        <p:spPr>
          <a:xfrm flipV="1">
            <a:off x="2890773" y="4989985"/>
            <a:ext cx="0" cy="79200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kstfelt 63">
            <a:extLst>
              <a:ext uri="{FF2B5EF4-FFF2-40B4-BE49-F238E27FC236}">
                <a16:creationId xmlns:a16="http://schemas.microsoft.com/office/drawing/2014/main" id="{D0911152-5A7D-4685-94A2-B51F5F072F03}"/>
              </a:ext>
            </a:extLst>
          </p:cNvPr>
          <p:cNvSpPr txBox="1"/>
          <p:nvPr/>
        </p:nvSpPr>
        <p:spPr>
          <a:xfrm>
            <a:off x="1429135" y="5201391"/>
            <a:ext cx="1447000" cy="336458"/>
          </a:xfrm>
          <a:prstGeom prst="rect">
            <a:avLst/>
          </a:prstGeom>
          <a:solidFill>
            <a:schemeClr val="accent5"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AT-2 antagonists 50 mg/ </a:t>
            </a:r>
          </a:p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ACE inhibitor 10 mg</a:t>
            </a:r>
          </a:p>
        </p:txBody>
      </p:sp>
      <p:sp>
        <p:nvSpPr>
          <p:cNvPr id="68" name="Tekstfelt 67">
            <a:extLst>
              <a:ext uri="{FF2B5EF4-FFF2-40B4-BE49-F238E27FC236}">
                <a16:creationId xmlns:a16="http://schemas.microsoft.com/office/drawing/2014/main" id="{F3FC66A7-6B13-4BF0-AA52-37B9B2D69490}"/>
              </a:ext>
            </a:extLst>
          </p:cNvPr>
          <p:cNvSpPr txBox="1"/>
          <p:nvPr/>
        </p:nvSpPr>
        <p:spPr>
          <a:xfrm>
            <a:off x="357155" y="5778217"/>
            <a:ext cx="1063112" cy="334835"/>
          </a:xfrm>
          <a:prstGeom prst="rect">
            <a:avLst/>
          </a:prstGeom>
          <a:solidFill>
            <a:schemeClr val="accent2">
              <a:lumMod val="60000"/>
              <a:lumOff val="40000"/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No </a:t>
            </a:r>
            <a:r>
              <a:rPr lang="da-DK" sz="788" b="1" dirty="0" err="1">
                <a:solidFill>
                  <a:prstClr val="black"/>
                </a:solidFill>
                <a:latin typeface="Calibri" panose="020F0502020204030204"/>
              </a:rPr>
              <a:t>glucose-lowering</a:t>
            </a:r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 </a:t>
            </a:r>
          </a:p>
          <a:p>
            <a:pPr algn="ctr" defTabSz="685800"/>
            <a:r>
              <a:rPr lang="da-DK" sz="788" b="1" dirty="0" err="1">
                <a:solidFill>
                  <a:prstClr val="black"/>
                </a:solidFill>
                <a:latin typeface="Calibri" panose="020F0502020204030204"/>
              </a:rPr>
              <a:t>medication</a:t>
            </a:r>
            <a:endParaRPr lang="da-DK" sz="788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69" name="Tekstfelt 68">
            <a:extLst>
              <a:ext uri="{FF2B5EF4-FFF2-40B4-BE49-F238E27FC236}">
                <a16:creationId xmlns:a16="http://schemas.microsoft.com/office/drawing/2014/main" id="{BA2F2E53-BC14-4B4F-B794-F30B495B14D6}"/>
              </a:ext>
            </a:extLst>
          </p:cNvPr>
          <p:cNvSpPr txBox="1"/>
          <p:nvPr/>
        </p:nvSpPr>
        <p:spPr>
          <a:xfrm>
            <a:off x="1435345" y="4995611"/>
            <a:ext cx="1459891" cy="213585"/>
          </a:xfrm>
          <a:prstGeom prst="rect">
            <a:avLst/>
          </a:prstGeom>
          <a:solidFill>
            <a:schemeClr val="accent2">
              <a:lumMod val="60000"/>
              <a:lumOff val="40000"/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 defTabSz="685800"/>
            <a:r>
              <a:rPr lang="da-DK" sz="788" b="1" dirty="0" err="1">
                <a:solidFill>
                  <a:prstClr val="black"/>
                </a:solidFill>
                <a:latin typeface="Calibri" panose="020F0502020204030204"/>
              </a:rPr>
              <a:t>Metformin</a:t>
            </a:r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 500 mg x  1-2</a:t>
            </a:r>
          </a:p>
        </p:txBody>
      </p:sp>
      <p:sp>
        <p:nvSpPr>
          <p:cNvPr id="70" name="Tekstfelt 69">
            <a:extLst>
              <a:ext uri="{FF2B5EF4-FFF2-40B4-BE49-F238E27FC236}">
                <a16:creationId xmlns:a16="http://schemas.microsoft.com/office/drawing/2014/main" id="{A5B9D22A-B55B-40AB-BC96-AA8B406F9119}"/>
              </a:ext>
            </a:extLst>
          </p:cNvPr>
          <p:cNvSpPr txBox="1"/>
          <p:nvPr/>
        </p:nvSpPr>
        <p:spPr>
          <a:xfrm>
            <a:off x="2907519" y="4219953"/>
            <a:ext cx="1345445" cy="213585"/>
          </a:xfrm>
          <a:prstGeom prst="rect">
            <a:avLst/>
          </a:prstGeom>
          <a:solidFill>
            <a:schemeClr val="accent2">
              <a:lumMod val="60000"/>
              <a:lumOff val="40000"/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 defTabSz="685800"/>
            <a:r>
              <a:rPr lang="da-DK" sz="788" b="1" dirty="0" err="1">
                <a:solidFill>
                  <a:prstClr val="black"/>
                </a:solidFill>
                <a:latin typeface="Calibri" panose="020F0502020204030204"/>
              </a:rPr>
              <a:t>Metformin</a:t>
            </a:r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 1000 mg x 2</a:t>
            </a:r>
          </a:p>
        </p:txBody>
      </p:sp>
      <p:sp>
        <p:nvSpPr>
          <p:cNvPr id="71" name="Tekstfelt 70">
            <a:extLst>
              <a:ext uri="{FF2B5EF4-FFF2-40B4-BE49-F238E27FC236}">
                <a16:creationId xmlns:a16="http://schemas.microsoft.com/office/drawing/2014/main" id="{9DCDE3D4-6B9A-4793-9DB6-FC6074576AB0}"/>
              </a:ext>
            </a:extLst>
          </p:cNvPr>
          <p:cNvSpPr txBox="1"/>
          <p:nvPr/>
        </p:nvSpPr>
        <p:spPr>
          <a:xfrm>
            <a:off x="4283253" y="2813484"/>
            <a:ext cx="1738042" cy="456087"/>
          </a:xfrm>
          <a:prstGeom prst="rect">
            <a:avLst/>
          </a:prstGeom>
          <a:solidFill>
            <a:schemeClr val="accent2">
              <a:lumMod val="60000"/>
              <a:lumOff val="40000"/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 defTabSz="685800"/>
            <a:r>
              <a:rPr lang="da-DK" sz="788" b="1" dirty="0" err="1">
                <a:solidFill>
                  <a:prstClr val="black"/>
                </a:solidFill>
                <a:latin typeface="Calibri" panose="020F0502020204030204"/>
              </a:rPr>
              <a:t>Metformin</a:t>
            </a:r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 1000 mg x 2 </a:t>
            </a:r>
          </a:p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+ </a:t>
            </a:r>
          </a:p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Empagliflozin 10-25 mg x 1</a:t>
            </a:r>
          </a:p>
        </p:txBody>
      </p:sp>
      <p:sp>
        <p:nvSpPr>
          <p:cNvPr id="72" name="Tekstfelt 71">
            <a:extLst>
              <a:ext uri="{FF2B5EF4-FFF2-40B4-BE49-F238E27FC236}">
                <a16:creationId xmlns:a16="http://schemas.microsoft.com/office/drawing/2014/main" id="{13E3D166-073F-4D17-8B51-E5AC572976B6}"/>
              </a:ext>
            </a:extLst>
          </p:cNvPr>
          <p:cNvSpPr txBox="1"/>
          <p:nvPr/>
        </p:nvSpPr>
        <p:spPr>
          <a:xfrm>
            <a:off x="6030865" y="1784647"/>
            <a:ext cx="2164961" cy="698589"/>
          </a:xfrm>
          <a:prstGeom prst="rect">
            <a:avLst/>
          </a:prstGeom>
          <a:solidFill>
            <a:schemeClr val="accent2">
              <a:lumMod val="60000"/>
              <a:lumOff val="40000"/>
              <a:alpha val="50000"/>
            </a:schemeClr>
          </a:solidFill>
          <a:ln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Metformin 1000 mg x 2 </a:t>
            </a:r>
          </a:p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+ </a:t>
            </a:r>
          </a:p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Empagliflozin 10-25 mg x 1 </a:t>
            </a:r>
          </a:p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+ </a:t>
            </a:r>
          </a:p>
          <a:p>
            <a:pPr algn="ctr" defTabSz="685800"/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Sitagliptin 25-100 mg x 1</a:t>
            </a:r>
          </a:p>
        </p:txBody>
      </p:sp>
      <p:sp>
        <p:nvSpPr>
          <p:cNvPr id="76" name="Tekstfelt 75">
            <a:extLst>
              <a:ext uri="{FF2B5EF4-FFF2-40B4-BE49-F238E27FC236}">
                <a16:creationId xmlns:a16="http://schemas.microsoft.com/office/drawing/2014/main" id="{318B42A0-35EB-4BAC-BDAD-38B98259FA79}"/>
              </a:ext>
            </a:extLst>
          </p:cNvPr>
          <p:cNvSpPr txBox="1"/>
          <p:nvPr/>
        </p:nvSpPr>
        <p:spPr>
          <a:xfrm>
            <a:off x="2907519" y="4772147"/>
            <a:ext cx="1345445" cy="21358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 defTabSz="457200"/>
            <a:r>
              <a:rPr lang="da-DK" sz="788" b="1" dirty="0" err="1">
                <a:solidFill>
                  <a:prstClr val="black"/>
                </a:solidFill>
                <a:latin typeface="Calibri" panose="020F0502020204030204"/>
              </a:rPr>
              <a:t>Atorvastatin</a:t>
            </a:r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 20 mg x 1</a:t>
            </a:r>
          </a:p>
        </p:txBody>
      </p:sp>
      <p:sp>
        <p:nvSpPr>
          <p:cNvPr id="77" name="Tekstfelt 76">
            <a:extLst>
              <a:ext uri="{FF2B5EF4-FFF2-40B4-BE49-F238E27FC236}">
                <a16:creationId xmlns:a16="http://schemas.microsoft.com/office/drawing/2014/main" id="{1F536E01-E1DD-436C-8162-A32A1CA52FFE}"/>
              </a:ext>
            </a:extLst>
          </p:cNvPr>
          <p:cNvSpPr txBox="1"/>
          <p:nvPr/>
        </p:nvSpPr>
        <p:spPr>
          <a:xfrm>
            <a:off x="4279568" y="3986775"/>
            <a:ext cx="1733293" cy="21358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 defTabSz="457200"/>
            <a:r>
              <a:rPr lang="da-DK" sz="788" b="1" dirty="0" err="1">
                <a:solidFill>
                  <a:prstClr val="black"/>
                </a:solidFill>
                <a:latin typeface="Calibri" panose="020F0502020204030204"/>
              </a:rPr>
              <a:t>Atorvastatin</a:t>
            </a:r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 40 mg x 1</a:t>
            </a:r>
          </a:p>
        </p:txBody>
      </p:sp>
      <p:sp>
        <p:nvSpPr>
          <p:cNvPr id="78" name="Tekstfelt 77">
            <a:extLst>
              <a:ext uri="{FF2B5EF4-FFF2-40B4-BE49-F238E27FC236}">
                <a16:creationId xmlns:a16="http://schemas.microsoft.com/office/drawing/2014/main" id="{862C39D7-BD31-4D15-88F1-BE159E04B054}"/>
              </a:ext>
            </a:extLst>
          </p:cNvPr>
          <p:cNvSpPr txBox="1"/>
          <p:nvPr/>
        </p:nvSpPr>
        <p:spPr>
          <a:xfrm>
            <a:off x="6029120" y="3176885"/>
            <a:ext cx="2164961" cy="21358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 defTabSz="457200"/>
            <a:r>
              <a:rPr lang="da-DK" sz="788" b="1" dirty="0" err="1">
                <a:solidFill>
                  <a:prstClr val="black"/>
                </a:solidFill>
                <a:latin typeface="Calibri" panose="020F0502020204030204"/>
              </a:rPr>
              <a:t>Atorvastatin</a:t>
            </a:r>
            <a:r>
              <a:rPr lang="da-DK" sz="788" b="1" dirty="0">
                <a:solidFill>
                  <a:prstClr val="black"/>
                </a:solidFill>
                <a:latin typeface="Calibri" panose="020F0502020204030204"/>
              </a:rPr>
              <a:t> 80 mg x 1</a:t>
            </a:r>
          </a:p>
        </p:txBody>
      </p:sp>
      <p:cxnSp>
        <p:nvCxnSpPr>
          <p:cNvPr id="33" name="Lige forbindelse 32">
            <a:extLst>
              <a:ext uri="{FF2B5EF4-FFF2-40B4-BE49-F238E27FC236}">
                <a16:creationId xmlns:a16="http://schemas.microsoft.com/office/drawing/2014/main" id="{5C30D1E7-7169-4D6D-908F-D3B6258ABE9B}"/>
              </a:ext>
            </a:extLst>
          </p:cNvPr>
          <p:cNvCxnSpPr>
            <a:cxnSpLocks/>
          </p:cNvCxnSpPr>
          <p:nvPr/>
        </p:nvCxnSpPr>
        <p:spPr>
          <a:xfrm flipV="1">
            <a:off x="6029120" y="3439191"/>
            <a:ext cx="0" cy="79200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kstfelt 29">
            <a:extLst>
              <a:ext uri="{FF2B5EF4-FFF2-40B4-BE49-F238E27FC236}">
                <a16:creationId xmlns:a16="http://schemas.microsoft.com/office/drawing/2014/main" id="{2E05FBDF-C0ED-4722-B229-9BB23802ED06}"/>
              </a:ext>
            </a:extLst>
          </p:cNvPr>
          <p:cNvSpPr txBox="1"/>
          <p:nvPr/>
        </p:nvSpPr>
        <p:spPr>
          <a:xfrm>
            <a:off x="8459078" y="2879320"/>
            <a:ext cx="3475938" cy="35394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800" dirty="0"/>
              <a:t>The individual need for pharmacological management of hyperglycaemia will be evaluated based on latest measured HbA1c. If HbA1c exceeds 53 mmol/mol the pharmacological treatment is intensified and the next step in the algorithm is prescribed. If HbA1c drops below 48 mmol/mol the pharmacological treatment is reduced corresponding to the previous step in the algorithm. In case of patient-reported symptoms of glycaemic dysregulation the participant will be asked to measure fasting and postprandial blood glucose with a glucose meter at home. Both blood glucose and reported symptoms will be taking into consideration when evaluating level of pharmacological treatment.   </a:t>
            </a:r>
            <a:endParaRPr lang="da-DK" sz="800" dirty="0"/>
          </a:p>
          <a:p>
            <a:r>
              <a:rPr lang="en-US" sz="800" dirty="0"/>
              <a:t> </a:t>
            </a:r>
            <a:endParaRPr lang="da-DK" sz="800" dirty="0"/>
          </a:p>
          <a:p>
            <a:r>
              <a:rPr lang="en-US" sz="800" dirty="0"/>
              <a:t>Blood pressure (BP) will be evaluated based on 3-days home blood pressure-measurements. Therapeutic target is average BP ≤ 130/80 mmHg. If target is not met the pharmacological treatment is intensified and the next step in the algorithm is prescribed. If average BP drops below 125/75 mmHg or the participant reports symptoms of hypotension, the pharmacological treatment is reduced corresponding to the previous step in the algorithm. </a:t>
            </a:r>
            <a:endParaRPr lang="da-DK" sz="800" dirty="0"/>
          </a:p>
          <a:p>
            <a:r>
              <a:rPr lang="en-US" sz="800" dirty="0"/>
              <a:t> </a:t>
            </a:r>
          </a:p>
          <a:p>
            <a:r>
              <a:rPr lang="en-US" sz="800" dirty="0"/>
              <a:t>Lipid lowering treatment will continue at any given dosage if LDL cholesterol </a:t>
            </a:r>
            <a:r>
              <a:rPr lang="en-US" sz="800"/>
              <a:t>is ˃ 2,5 </a:t>
            </a:r>
            <a:r>
              <a:rPr lang="en-US" sz="800" dirty="0"/>
              <a:t>mmol/L at inclusion. If LDL is measured above 2,5 mmol/L at inclusion or at 4- or 12-weeks follow-up, the pharmacological treatment is intensified according to the algorithm. No indication for reduction in pharmacological treatment.</a:t>
            </a:r>
          </a:p>
          <a:p>
            <a:endParaRPr lang="en-US" sz="800" dirty="0"/>
          </a:p>
          <a:p>
            <a:r>
              <a:rPr lang="en-US" sz="800" dirty="0"/>
              <a:t>Dosage of glucose lowering-, blood pressure lowering- and lipid lowering medication is adjusted independently of each other, e.g. intensification of glucose lowering medication is not necessarily accompanied by increase in lipid lowering medication.</a:t>
            </a:r>
            <a:endParaRPr lang="da-DK" sz="800" dirty="0"/>
          </a:p>
          <a:p>
            <a:endParaRPr lang="da-DK" sz="800" dirty="0"/>
          </a:p>
        </p:txBody>
      </p:sp>
    </p:spTree>
    <p:extLst>
      <p:ext uri="{BB962C8B-B14F-4D97-AF65-F5344CB8AC3E}">
        <p14:creationId xmlns:p14="http://schemas.microsoft.com/office/powerpoint/2010/main" val="293778871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</TotalTime>
  <Words>509</Words>
  <Application>Microsoft Office PowerPoint</Application>
  <PresentationFormat>Widescreen</PresentationFormat>
  <Paragraphs>64</Paragraphs>
  <Slides>1</Slides>
  <Notes>1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5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imes New Roman</vt:lpstr>
      <vt:lpstr>1_Office-tema</vt:lpstr>
      <vt:lpstr>PowerPoint-præ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Grit Elster Legård</dc:creator>
  <cp:lastModifiedBy>Mark Lyngbæk</cp:lastModifiedBy>
  <cp:revision>12</cp:revision>
  <dcterms:created xsi:type="dcterms:W3CDTF">2020-09-07T12:45:33Z</dcterms:created>
  <dcterms:modified xsi:type="dcterms:W3CDTF">2020-09-16T07:14:10Z</dcterms:modified>
</cp:coreProperties>
</file>